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4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54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0719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9157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1408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8752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8958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9191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8216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8700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8344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8988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7895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0E8B2C-25F6-4E65-B660-A4BF11E743CA}" type="datetimeFigureOut">
              <a:rPr lang="ko-KR" altLang="en-US" smtClean="0"/>
              <a:t>2019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FB3F0-EA6A-4A9A-B965-58264BDA1C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2431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AD870434-790E-4BAB-9867-7250C3658B89}"/>
              </a:ext>
            </a:extLst>
          </p:cNvPr>
          <p:cNvGrpSpPr/>
          <p:nvPr/>
        </p:nvGrpSpPr>
        <p:grpSpPr>
          <a:xfrm>
            <a:off x="298324" y="1952483"/>
            <a:ext cx="2662589" cy="2190207"/>
            <a:chOff x="1413022" y="149809"/>
            <a:chExt cx="2662589" cy="2190207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33C6989-84A1-4FA1-93D6-FEED54BDD078}"/>
                </a:ext>
              </a:extLst>
            </p:cNvPr>
            <p:cNvSpPr txBox="1"/>
            <p:nvPr/>
          </p:nvSpPr>
          <p:spPr>
            <a:xfrm>
              <a:off x="1531275" y="149809"/>
              <a:ext cx="12751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a. The first model</a:t>
              </a:r>
              <a:endParaRPr lang="ko-KR" altLang="en-US" sz="1200" dirty="0"/>
            </a:p>
          </p:txBody>
        </p:sp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52898252-F4E1-47CB-9E9C-B40CB6C8594C}"/>
                </a:ext>
              </a:extLst>
            </p:cNvPr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13022" y="487769"/>
              <a:ext cx="2662589" cy="1852247"/>
            </a:xfrm>
            <a:prstGeom prst="rect">
              <a:avLst/>
            </a:prstGeom>
          </p:spPr>
        </p:pic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55733E26-2F9C-4F39-AB4C-2D6642471397}"/>
              </a:ext>
            </a:extLst>
          </p:cNvPr>
          <p:cNvGrpSpPr/>
          <p:nvPr/>
        </p:nvGrpSpPr>
        <p:grpSpPr>
          <a:xfrm>
            <a:off x="3196047" y="1952483"/>
            <a:ext cx="2662588" cy="2190207"/>
            <a:chOff x="1413023" y="2400976"/>
            <a:chExt cx="2662588" cy="2190207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B977BEE-4B8C-4C18-8B09-E900F69FD865}"/>
                </a:ext>
              </a:extLst>
            </p:cNvPr>
            <p:cNvSpPr txBox="1"/>
            <p:nvPr/>
          </p:nvSpPr>
          <p:spPr>
            <a:xfrm>
              <a:off x="1542348" y="2400976"/>
              <a:ext cx="14834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b. The second model</a:t>
              </a:r>
              <a:endParaRPr lang="ko-KR" altLang="en-US" sz="1200" dirty="0"/>
            </a:p>
          </p:txBody>
        </p:sp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3D83DE2B-ED90-4F2E-9904-513B0E160AC4}"/>
                </a:ext>
              </a:extLst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13023" y="2738936"/>
              <a:ext cx="2662588" cy="1852247"/>
            </a:xfrm>
            <a:prstGeom prst="rect">
              <a:avLst/>
            </a:prstGeom>
          </p:spPr>
        </p:pic>
      </p:grpSp>
      <p:grpSp>
        <p:nvGrpSpPr>
          <p:cNvPr id="16" name="그룹 15">
            <a:extLst>
              <a:ext uri="{FF2B5EF4-FFF2-40B4-BE49-F238E27FC236}">
                <a16:creationId xmlns:a16="http://schemas.microsoft.com/office/drawing/2014/main" id="{4DF58379-3449-4AC3-8106-B35A27BC9975}"/>
              </a:ext>
            </a:extLst>
          </p:cNvPr>
          <p:cNvGrpSpPr/>
          <p:nvPr/>
        </p:nvGrpSpPr>
        <p:grpSpPr>
          <a:xfrm>
            <a:off x="6093769" y="1952483"/>
            <a:ext cx="2662588" cy="2190207"/>
            <a:chOff x="1413022" y="4591182"/>
            <a:chExt cx="2662588" cy="2190207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9CCDA95-2F0C-4B9F-B6CB-C9C877AEAEF6}"/>
                </a:ext>
              </a:extLst>
            </p:cNvPr>
            <p:cNvSpPr txBox="1"/>
            <p:nvPr/>
          </p:nvSpPr>
          <p:spPr>
            <a:xfrm>
              <a:off x="1603295" y="4591182"/>
              <a:ext cx="13222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c. The third model</a:t>
              </a:r>
              <a:endParaRPr lang="ko-KR" altLang="en-US" sz="1200" dirty="0"/>
            </a:p>
          </p:txBody>
        </p:sp>
        <p:pic>
          <p:nvPicPr>
            <p:cNvPr id="15" name="그림 14">
              <a:extLst>
                <a:ext uri="{FF2B5EF4-FFF2-40B4-BE49-F238E27FC236}">
                  <a16:creationId xmlns:a16="http://schemas.microsoft.com/office/drawing/2014/main" id="{885C3D06-DE3A-49B5-B8AB-340216447076}"/>
                </a:ext>
              </a:extLst>
            </p:cNvPr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142"/>
            <a:stretch/>
          </p:blipFill>
          <p:spPr>
            <a:xfrm>
              <a:off x="1413022" y="4937810"/>
              <a:ext cx="2662588" cy="1843579"/>
            </a:xfrm>
            <a:prstGeom prst="rect">
              <a:avLst/>
            </a:prstGeom>
          </p:spPr>
        </p:pic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D86C1CA7-E8DA-4358-AB14-FA644E1A6187}"/>
              </a:ext>
            </a:extLst>
          </p:cNvPr>
          <p:cNvSpPr txBox="1"/>
          <p:nvPr/>
        </p:nvSpPr>
        <p:spPr>
          <a:xfrm>
            <a:off x="1682999" y="4080540"/>
            <a:ext cx="12779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Theoretical quantiles</a:t>
            </a:r>
            <a:endParaRPr lang="ko-KR" altLang="en-US" sz="1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3F9D871-1686-4F56-BFB1-F86C55620DA6}"/>
              </a:ext>
            </a:extLst>
          </p:cNvPr>
          <p:cNvSpPr txBox="1"/>
          <p:nvPr/>
        </p:nvSpPr>
        <p:spPr>
          <a:xfrm>
            <a:off x="4581286" y="4080540"/>
            <a:ext cx="12779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Theoretical quantiles</a:t>
            </a:r>
            <a:endParaRPr lang="ko-KR" alt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9B4994F-18F2-4848-847B-65D9B802AB36}"/>
              </a:ext>
            </a:extLst>
          </p:cNvPr>
          <p:cNvSpPr txBox="1"/>
          <p:nvPr/>
        </p:nvSpPr>
        <p:spPr>
          <a:xfrm>
            <a:off x="7477313" y="4086659"/>
            <a:ext cx="12779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Theoretical quantiles</a:t>
            </a:r>
            <a:endParaRPr lang="ko-KR" altLang="en-US" sz="1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AA9C82-9AB6-4610-9C6E-B38CCEE9CA28}"/>
              </a:ext>
            </a:extLst>
          </p:cNvPr>
          <p:cNvSpPr txBox="1"/>
          <p:nvPr/>
        </p:nvSpPr>
        <p:spPr>
          <a:xfrm>
            <a:off x="84341" y="2299111"/>
            <a:ext cx="338554" cy="84253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000" dirty="0"/>
              <a:t>Data quantiles</a:t>
            </a:r>
            <a:endParaRPr lang="ko-KR" alt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AA04EC7-0284-4DFC-BFDA-85F869E72A27}"/>
              </a:ext>
            </a:extLst>
          </p:cNvPr>
          <p:cNvSpPr txBox="1"/>
          <p:nvPr/>
        </p:nvSpPr>
        <p:spPr>
          <a:xfrm>
            <a:off x="2986818" y="2299111"/>
            <a:ext cx="338554" cy="84253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000" dirty="0"/>
              <a:t>Data quantiles</a:t>
            </a:r>
            <a:endParaRPr lang="ko-KR" alt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E2A9BE6-5925-426C-9A16-AA19CB0494F9}"/>
              </a:ext>
            </a:extLst>
          </p:cNvPr>
          <p:cNvSpPr txBox="1"/>
          <p:nvPr/>
        </p:nvSpPr>
        <p:spPr>
          <a:xfrm>
            <a:off x="5923927" y="2299111"/>
            <a:ext cx="338554" cy="84253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1000" dirty="0"/>
              <a:t>Data quantiles</a:t>
            </a:r>
            <a:endParaRPr lang="ko-KR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80150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27</Words>
  <Application>Microsoft Office PowerPoint</Application>
  <PresentationFormat>화면 슬라이드 쇼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 보미</dc:creator>
  <cp:lastModifiedBy>박 보미</cp:lastModifiedBy>
  <cp:revision>9</cp:revision>
  <dcterms:created xsi:type="dcterms:W3CDTF">2019-09-22T14:41:33Z</dcterms:created>
  <dcterms:modified xsi:type="dcterms:W3CDTF">2019-09-25T06:34:30Z</dcterms:modified>
</cp:coreProperties>
</file>